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56" r:id="rId2"/>
    <p:sldId id="257" r:id="rId3"/>
    <p:sldId id="258" r:id="rId4"/>
  </p:sldIdLst>
  <p:sldSz cx="7920038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61086" autoAdjust="0"/>
  </p:normalViewPr>
  <p:slideViewPr>
    <p:cSldViewPr snapToGrid="0">
      <p:cViewPr varScale="1">
        <p:scale>
          <a:sx n="42" d="100"/>
          <a:sy n="42" d="100"/>
        </p:scale>
        <p:origin x="277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7232A8-331F-45A1-B6DF-30333C323BD4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143000"/>
            <a:ext cx="2425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F56662-1D7B-4C7E-81FF-BB1975B2626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872174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is </a:t>
            </a:r>
            <a:r>
              <a:rPr lang="en-US" dirty="0" smtClean="0"/>
              <a:t>Cumming </a:t>
            </a:r>
            <a:r>
              <a:rPr lang="en-US" dirty="0" smtClean="0"/>
              <a:t>estimation</a:t>
            </a:r>
            <a:r>
              <a:rPr lang="en-US" baseline="0" dirty="0" smtClean="0"/>
              <a:t> plots</a:t>
            </a:r>
            <a:r>
              <a:rPr lang="en-US" dirty="0" smtClean="0"/>
              <a:t> </a:t>
            </a:r>
            <a:r>
              <a:rPr lang="en-US" dirty="0" smtClean="0"/>
              <a:t>show </a:t>
            </a:r>
            <a:r>
              <a:rPr lang="en-US" dirty="0" smtClean="0"/>
              <a:t>the </a:t>
            </a:r>
            <a:r>
              <a:rPr lang="en-US" dirty="0" smtClean="0"/>
              <a:t>individual data for the solid ground condition of all</a:t>
            </a:r>
            <a:r>
              <a:rPr lang="en-US" baseline="0" dirty="0" smtClean="0"/>
              <a:t> </a:t>
            </a:r>
            <a:r>
              <a:rPr lang="en-US" baseline="0" dirty="0" smtClean="0"/>
              <a:t>volunteers for PRE and POST assessments. </a:t>
            </a:r>
            <a:r>
              <a:rPr lang="en-US" baseline="0" dirty="0" smtClean="0"/>
              <a:t>The data for each group (HIIT-BALANCE vs. BALANCE vs. BALANCE-HIIT) are each outlined by a black rectangle. Within each black rectangle, the left part shows the raw data (upper part) and the paired Cohen's d (lower part) for the PRE and POST assessments in the non-fatigued test condition (NF), while the data collected in the fatigued condition (F) are shown on the right.</a:t>
            </a:r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F56662-1D7B-4C7E-81FF-BB1975B2626E}" type="slidenum">
              <a:rPr lang="de-CH" smtClean="0"/>
              <a:t>1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114552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his Cumming estimation</a:t>
            </a:r>
            <a:r>
              <a:rPr lang="en-US" baseline="0" dirty="0" smtClean="0"/>
              <a:t> plots</a:t>
            </a:r>
            <a:r>
              <a:rPr lang="en-US" dirty="0" smtClean="0"/>
              <a:t> show the individual data for the soft mat condition of all</a:t>
            </a:r>
            <a:r>
              <a:rPr lang="en-US" baseline="0" dirty="0" smtClean="0"/>
              <a:t> volunteers for PRE and POST assessments. The data for each group (HIIT-BALANCE vs. BALANCE vs. BALANCE-HIIT) are each outlined by a black rectangle. Within each black rectangle, the left part shows the raw data (upper part) and the paired Cohen's d (lower part) for the PRE and POST assessments in the non-fatigued test condition (NF), while the data collected in the fatigued condition (F) are shown on the right.</a:t>
            </a:r>
            <a:endParaRPr lang="de-CH" dirty="0" smtClean="0"/>
          </a:p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F56662-1D7B-4C7E-81FF-BB1975B2626E}" type="slidenum">
              <a:rPr lang="de-CH" smtClean="0"/>
              <a:t>2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1171693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his Cumming estimation</a:t>
            </a:r>
            <a:r>
              <a:rPr lang="en-US" baseline="0" dirty="0" smtClean="0"/>
              <a:t> plots</a:t>
            </a:r>
            <a:r>
              <a:rPr lang="en-US" dirty="0" smtClean="0"/>
              <a:t> show the individual data for the </a:t>
            </a:r>
            <a:r>
              <a:rPr lang="en-US" smtClean="0"/>
              <a:t>wobble board condition </a:t>
            </a:r>
            <a:r>
              <a:rPr lang="en-US" dirty="0" smtClean="0"/>
              <a:t>of all</a:t>
            </a:r>
            <a:r>
              <a:rPr lang="en-US" baseline="0" dirty="0" smtClean="0"/>
              <a:t> volunteers for PRE and POST assessments. The data for each group (HIIT-BALANCE vs. BALANCE vs. BALANCE-HIIT) are each outlined by a black rectangle. Within each black rectangle, the left part shows the raw data (upper part) and the paired Cohen's d (lower part) for the PRE and POST assessments in the non-fatigued test condition (NF), while the data collected in the fatigued condition (F) are shown on the right.</a:t>
            </a:r>
            <a:endParaRPr lang="de-CH" dirty="0" smtClean="0"/>
          </a:p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F56662-1D7B-4C7E-81FF-BB1975B2626E}" type="slidenum">
              <a:rPr lang="de-CH" smtClean="0"/>
              <a:t>3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82750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1649770"/>
            <a:ext cx="6732032" cy="3509551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5294662"/>
            <a:ext cx="5940029" cy="2433817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00407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11853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536700"/>
            <a:ext cx="1707758" cy="8542864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536700"/>
            <a:ext cx="5024274" cy="8542864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51440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89807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2513159"/>
            <a:ext cx="6831033" cy="4193259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6746088"/>
            <a:ext cx="6831033" cy="2205136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/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75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1698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2683500"/>
            <a:ext cx="3366016" cy="6396064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2683500"/>
            <a:ext cx="3366016" cy="6396064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34465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536702"/>
            <a:ext cx="6831033" cy="194845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2471154"/>
            <a:ext cx="3350547" cy="1211074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3682228"/>
            <a:ext cx="3350547" cy="541600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2471154"/>
            <a:ext cx="3367048" cy="1211074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3682228"/>
            <a:ext cx="3367048" cy="541600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90042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3172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49732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672042"/>
            <a:ext cx="2554418" cy="2352146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1451426"/>
            <a:ext cx="4009519" cy="7163777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3024188"/>
            <a:ext cx="2554418" cy="5602681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75508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672042"/>
            <a:ext cx="2554418" cy="2352146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1451426"/>
            <a:ext cx="4009519" cy="7163777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3024188"/>
            <a:ext cx="2554418" cy="5602681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86023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536702"/>
            <a:ext cx="6831033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2683500"/>
            <a:ext cx="6831033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9343248"/>
            <a:ext cx="1782009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6A3C69-1BC5-4D5A-8D78-945CBA09A01E}" type="datetimeFigureOut">
              <a:rPr lang="de-CH" smtClean="0"/>
              <a:t>17.04.2023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9343248"/>
            <a:ext cx="2673013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9343248"/>
            <a:ext cx="1782009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21B52A-14E1-43F7-B7DB-FD70F186FF49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4616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gif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gif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gif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/>
          <p:cNvSpPr txBox="1"/>
          <p:nvPr/>
        </p:nvSpPr>
        <p:spPr>
          <a:xfrm>
            <a:off x="1690260" y="5292040"/>
            <a:ext cx="920188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BALANCE</a:t>
            </a:r>
            <a:endParaRPr lang="de-CH" sz="1488" b="1" dirty="0"/>
          </a:p>
        </p:txBody>
      </p:sp>
      <p:sp>
        <p:nvSpPr>
          <p:cNvPr id="12" name="Textfeld 11"/>
          <p:cNvSpPr txBox="1"/>
          <p:nvPr/>
        </p:nvSpPr>
        <p:spPr>
          <a:xfrm>
            <a:off x="5716725" y="5292040"/>
            <a:ext cx="1295291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BALANCE-HIIT</a:t>
            </a:r>
            <a:endParaRPr lang="de-CH" sz="1488" b="1" dirty="0"/>
          </a:p>
        </p:txBody>
      </p:sp>
      <p:sp>
        <p:nvSpPr>
          <p:cNvPr id="13" name="Textfeld 12"/>
          <p:cNvSpPr txBox="1"/>
          <p:nvPr/>
        </p:nvSpPr>
        <p:spPr>
          <a:xfrm>
            <a:off x="5716724" y="275557"/>
            <a:ext cx="1295291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HIIT-BALANCE</a:t>
            </a:r>
            <a:endParaRPr lang="de-CH" sz="1488" b="1" dirty="0"/>
          </a:p>
        </p:txBody>
      </p:sp>
      <p:pic>
        <p:nvPicPr>
          <p:cNvPr id="14" name="Inhaltsplatzhalter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9863" y="614339"/>
            <a:ext cx="3616014" cy="4351338"/>
          </a:xfrm>
          <a:prstGeom prst="rect">
            <a:avLst/>
          </a:prstGeom>
        </p:spPr>
      </p:pic>
      <p:pic>
        <p:nvPicPr>
          <p:cNvPr id="15" name="Inhaltsplatzhalter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9863" y="5613346"/>
            <a:ext cx="3616014" cy="4351338"/>
          </a:xfrm>
          <a:prstGeom prst="rect">
            <a:avLst/>
          </a:prstGeom>
        </p:spPr>
      </p:pic>
      <p:pic>
        <p:nvPicPr>
          <p:cNvPr id="16" name="Inhaltsplatzhalter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112" y="5613346"/>
            <a:ext cx="3586047" cy="4351338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160" y="0"/>
            <a:ext cx="3780000" cy="5040000"/>
          </a:xfrm>
          <a:prstGeom prst="rect">
            <a:avLst/>
          </a:prstGeom>
        </p:spPr>
      </p:pic>
      <p:sp>
        <p:nvSpPr>
          <p:cNvPr id="21" name="Rechteck 20"/>
          <p:cNvSpPr/>
          <p:nvPr/>
        </p:nvSpPr>
        <p:spPr>
          <a:xfrm>
            <a:off x="4096989" y="47498"/>
            <a:ext cx="3747643" cy="4932000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22" name="Rechteck 21"/>
          <p:cNvSpPr/>
          <p:nvPr/>
        </p:nvSpPr>
        <p:spPr>
          <a:xfrm>
            <a:off x="4101145" y="5083096"/>
            <a:ext cx="3747643" cy="4932000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23" name="Rechteck 22"/>
          <p:cNvSpPr/>
          <p:nvPr/>
        </p:nvSpPr>
        <p:spPr>
          <a:xfrm>
            <a:off x="167253" y="5083096"/>
            <a:ext cx="3747643" cy="4932000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4462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nhaltsplatzhalter 5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5274" y="353085"/>
            <a:ext cx="3616014" cy="4351338"/>
          </a:xfrm>
        </p:spPr>
      </p:pic>
      <p:pic>
        <p:nvPicPr>
          <p:cNvPr id="5" name="Inhaltsplatzhalter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5274" y="5528747"/>
            <a:ext cx="3616014" cy="4351338"/>
          </a:xfrm>
          <a:prstGeom prst="rect">
            <a:avLst/>
          </a:prstGeom>
        </p:spPr>
      </p:pic>
      <p:pic>
        <p:nvPicPr>
          <p:cNvPr id="6" name="Inhaltsplatzhalter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125" y="5528747"/>
            <a:ext cx="3616014" cy="4351338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1690260" y="5208915"/>
            <a:ext cx="920188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BALANCE</a:t>
            </a:r>
            <a:endParaRPr lang="de-CH" sz="1488" b="1" dirty="0"/>
          </a:p>
        </p:txBody>
      </p:sp>
      <p:sp>
        <p:nvSpPr>
          <p:cNvPr id="8" name="Textfeld 7"/>
          <p:cNvSpPr txBox="1"/>
          <p:nvPr/>
        </p:nvSpPr>
        <p:spPr>
          <a:xfrm>
            <a:off x="5621725" y="5208915"/>
            <a:ext cx="1295291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BALANCE-HIIT</a:t>
            </a:r>
            <a:endParaRPr lang="de-CH" sz="1488" b="1" dirty="0"/>
          </a:p>
        </p:txBody>
      </p:sp>
      <p:sp>
        <p:nvSpPr>
          <p:cNvPr id="9" name="Textfeld 8"/>
          <p:cNvSpPr txBox="1"/>
          <p:nvPr/>
        </p:nvSpPr>
        <p:spPr>
          <a:xfrm>
            <a:off x="5621724" y="192432"/>
            <a:ext cx="1295291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HIIT-BALANCE</a:t>
            </a:r>
            <a:endParaRPr lang="de-CH" sz="1488" b="1" dirty="0"/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784" y="0"/>
            <a:ext cx="3780000" cy="5040000"/>
          </a:xfrm>
          <a:prstGeom prst="rect">
            <a:avLst/>
          </a:prstGeom>
        </p:spPr>
      </p:pic>
      <p:sp>
        <p:nvSpPr>
          <p:cNvPr id="12" name="Rechteck 11"/>
          <p:cNvSpPr/>
          <p:nvPr/>
        </p:nvSpPr>
        <p:spPr>
          <a:xfrm>
            <a:off x="4096989" y="47500"/>
            <a:ext cx="3747643" cy="4932000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3" name="Rechteck 12"/>
          <p:cNvSpPr/>
          <p:nvPr/>
        </p:nvSpPr>
        <p:spPr>
          <a:xfrm>
            <a:off x="4101145" y="5083098"/>
            <a:ext cx="3747643" cy="4932000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4" name="Rechteck 13"/>
          <p:cNvSpPr/>
          <p:nvPr/>
        </p:nvSpPr>
        <p:spPr>
          <a:xfrm>
            <a:off x="167253" y="5083098"/>
            <a:ext cx="3747643" cy="4932000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749704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773385" y="5208915"/>
            <a:ext cx="920188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BALANCE</a:t>
            </a:r>
            <a:endParaRPr lang="de-CH" sz="1488" b="1" dirty="0"/>
          </a:p>
        </p:txBody>
      </p:sp>
      <p:sp>
        <p:nvSpPr>
          <p:cNvPr id="5" name="Textfeld 4"/>
          <p:cNvSpPr txBox="1"/>
          <p:nvPr/>
        </p:nvSpPr>
        <p:spPr>
          <a:xfrm>
            <a:off x="5645475" y="5208915"/>
            <a:ext cx="1295291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BALANCE-HIIT</a:t>
            </a:r>
            <a:endParaRPr lang="de-CH" sz="1488" b="1" dirty="0"/>
          </a:p>
        </p:txBody>
      </p:sp>
      <p:sp>
        <p:nvSpPr>
          <p:cNvPr id="6" name="Textfeld 5"/>
          <p:cNvSpPr txBox="1"/>
          <p:nvPr/>
        </p:nvSpPr>
        <p:spPr>
          <a:xfrm>
            <a:off x="5645474" y="192432"/>
            <a:ext cx="1295291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HIIT-BALANCE</a:t>
            </a:r>
            <a:endParaRPr lang="de-CH" sz="1488" b="1" dirty="0"/>
          </a:p>
        </p:txBody>
      </p:sp>
      <p:pic>
        <p:nvPicPr>
          <p:cNvPr id="7" name="Inhaltsplatzhalter 5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6743" y="495589"/>
            <a:ext cx="3616014" cy="4351338"/>
          </a:xfrm>
        </p:spPr>
      </p:pic>
      <p:pic>
        <p:nvPicPr>
          <p:cNvPr id="8" name="Inhaltsplatzhalter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6743" y="5506978"/>
            <a:ext cx="3616014" cy="4351338"/>
          </a:xfrm>
          <a:prstGeom prst="rect">
            <a:avLst/>
          </a:prstGeom>
        </p:spPr>
      </p:pic>
      <p:pic>
        <p:nvPicPr>
          <p:cNvPr id="9" name="Inhaltsplatzhalter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253" y="5506978"/>
            <a:ext cx="3616014" cy="4351338"/>
          </a:xfrm>
          <a:prstGeom prst="rect">
            <a:avLst/>
          </a:prstGeom>
        </p:spPr>
      </p:pic>
      <p:sp>
        <p:nvSpPr>
          <p:cNvPr id="10" name="Rechteck 9"/>
          <p:cNvSpPr/>
          <p:nvPr/>
        </p:nvSpPr>
        <p:spPr>
          <a:xfrm>
            <a:off x="4096989" y="47500"/>
            <a:ext cx="3747643" cy="4932000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3" name="Rechteck 12"/>
          <p:cNvSpPr/>
          <p:nvPr/>
        </p:nvSpPr>
        <p:spPr>
          <a:xfrm>
            <a:off x="4101145" y="5083098"/>
            <a:ext cx="3747643" cy="4932000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4" name="Rechteck 13"/>
          <p:cNvSpPr/>
          <p:nvPr/>
        </p:nvSpPr>
        <p:spPr>
          <a:xfrm>
            <a:off x="167253" y="5083098"/>
            <a:ext cx="3747643" cy="4932000"/>
          </a:xfrm>
          <a:prstGeom prst="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409" y="0"/>
            <a:ext cx="3780000" cy="50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2607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12</Words>
  <Application>Microsoft Office PowerPoint</Application>
  <PresentationFormat>Benutzerdefiniert</PresentationFormat>
  <Paragraphs>15</Paragraphs>
  <Slides>3</Slides>
  <Notes>3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Universität Base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 Keller</dc:creator>
  <cp:lastModifiedBy>Martin Keller</cp:lastModifiedBy>
  <cp:revision>8</cp:revision>
  <dcterms:created xsi:type="dcterms:W3CDTF">2023-04-14T08:08:41Z</dcterms:created>
  <dcterms:modified xsi:type="dcterms:W3CDTF">2023-04-17T10:21:53Z</dcterms:modified>
</cp:coreProperties>
</file>